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8" r:id="rId4"/>
    <p:sldId id="259" r:id="rId5"/>
    <p:sldId id="265" r:id="rId6"/>
    <p:sldId id="267" r:id="rId7"/>
    <p:sldId id="26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166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410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520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912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558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601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132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639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011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61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56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7658-ABE4-49D2-BEAD-730833CCBC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361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027207"/>
            <a:ext cx="9144000" cy="1482755"/>
          </a:xfrm>
        </p:spPr>
        <p:txBody>
          <a:bodyPr>
            <a:noAutofit/>
          </a:bodyPr>
          <a:lstStyle/>
          <a:p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GSEA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of 247 genes linked by GREAT with 351 human-specific LTR7 and LTR5_Hs using the Enrichr bioinformatics platform (A – F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b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elated to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Inference of putative phenotypic impacts of human-specific LTR7 &amp; LTR5_Hs loci based on GREAT algorithm-guided functional annotations of proximity placement-linked genes. </a:t>
            </a:r>
            <a:endParaRPr lang="en-US" sz="18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175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5212" y="523875"/>
            <a:ext cx="4981575" cy="58102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4377" y="198408"/>
            <a:ext cx="318920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351 </a:t>
            </a:r>
            <a:r>
              <a:rPr lang="en-US" sz="1400" b="1" dirty="0" err="1" smtClean="0"/>
              <a:t>hs</a:t>
            </a:r>
            <a:r>
              <a:rPr lang="en-US" sz="1400" b="1" dirty="0" smtClean="0"/>
              <a:t> LTR7 &amp; LTR5_Hs loci</a:t>
            </a:r>
          </a:p>
          <a:p>
            <a:pPr algn="ctr"/>
            <a:r>
              <a:rPr lang="en-US" sz="1400" b="1" dirty="0" smtClean="0"/>
              <a:t>247 genes: </a:t>
            </a:r>
          </a:p>
          <a:p>
            <a:pPr algn="ctr"/>
            <a:r>
              <a:rPr lang="en-US" sz="1400" b="1" dirty="0" err="1" smtClean="0"/>
              <a:t>lncHUB</a:t>
            </a:r>
            <a:r>
              <a:rPr lang="en-US" sz="1400" b="1" dirty="0" smtClean="0"/>
              <a:t> lncRNA co-expression database; </a:t>
            </a:r>
          </a:p>
          <a:p>
            <a:pPr algn="ctr"/>
            <a:r>
              <a:rPr lang="en-US" sz="1400" b="1" dirty="0" smtClean="0"/>
              <a:t>top 10 significantly enriched records</a:t>
            </a:r>
            <a:endParaRPr lang="en-US" sz="1400" b="1" dirty="0"/>
          </a:p>
        </p:txBody>
      </p:sp>
      <p:sp>
        <p:nvSpPr>
          <p:cNvPr id="5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59266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47 genes</a:t>
            </a:r>
            <a:endParaRPr lang="en-US" b="1" dirty="0"/>
          </a:p>
        </p:txBody>
      </p:sp>
      <p:pic>
        <p:nvPicPr>
          <p:cNvPr id="2050" name="Picture 2" descr="https://appyters.maayanlab.cloud/Enrichment_Analysis_Visualizer/07eaa3afd4eb745a668d45a726445b695bd6182b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2060" y="2233228"/>
            <a:ext cx="6012612" cy="3839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65111" y="1062807"/>
            <a:ext cx="4487128" cy="4986768"/>
          </a:xfrm>
          <a:prstGeom prst="rect">
            <a:avLst/>
          </a:prstGeom>
        </p:spPr>
      </p:pic>
      <p:sp>
        <p:nvSpPr>
          <p:cNvPr id="6" name="5-Point Star 5"/>
          <p:cNvSpPr/>
          <p:nvPr/>
        </p:nvSpPr>
        <p:spPr>
          <a:xfrm>
            <a:off x="4710022" y="1502398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5-Point Star 7"/>
          <p:cNvSpPr/>
          <p:nvPr/>
        </p:nvSpPr>
        <p:spPr>
          <a:xfrm>
            <a:off x="3950899" y="1502401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5-Point Star 8"/>
          <p:cNvSpPr/>
          <p:nvPr/>
        </p:nvSpPr>
        <p:spPr>
          <a:xfrm>
            <a:off x="3464944" y="1502400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5-Point Star 9"/>
          <p:cNvSpPr/>
          <p:nvPr/>
        </p:nvSpPr>
        <p:spPr>
          <a:xfrm>
            <a:off x="4948686" y="1502399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5-Point Star 10"/>
          <p:cNvSpPr/>
          <p:nvPr/>
        </p:nvSpPr>
        <p:spPr>
          <a:xfrm>
            <a:off x="794988" y="6054331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" name="TextBox 6"/>
          <p:cNvSpPr txBox="1"/>
          <p:nvPr/>
        </p:nvSpPr>
        <p:spPr>
          <a:xfrm>
            <a:off x="1353399" y="5989526"/>
            <a:ext cx="2731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etal Gonad Marker Genes</a:t>
            </a:r>
            <a:endParaRPr lang="en-US" b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3296495" y="2357839"/>
            <a:ext cx="1153837" cy="0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4710022" y="2357839"/>
            <a:ext cx="911885" cy="8792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19068" y="6528123"/>
            <a:ext cx="455943" cy="1466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353399" y="6348341"/>
            <a:ext cx="3886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ïve Primed Pluripotent States Genes</a:t>
            </a:r>
            <a:endParaRPr lang="en-US" b="1" dirty="0"/>
          </a:p>
        </p:txBody>
      </p:sp>
      <p:sp>
        <p:nvSpPr>
          <p:cNvPr id="15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58492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5212" y="523875"/>
            <a:ext cx="4981575" cy="58102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84377" y="198408"/>
            <a:ext cx="318920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351 </a:t>
            </a:r>
            <a:r>
              <a:rPr lang="en-US" sz="1400" b="1" dirty="0" err="1" smtClean="0"/>
              <a:t>hs</a:t>
            </a:r>
            <a:r>
              <a:rPr lang="en-US" sz="1400" b="1" dirty="0" smtClean="0"/>
              <a:t> LTR7 &amp; LTR5_Hs loci</a:t>
            </a:r>
          </a:p>
          <a:p>
            <a:pPr algn="ctr"/>
            <a:r>
              <a:rPr lang="en-US" sz="1400" b="1" dirty="0" smtClean="0"/>
              <a:t>247 genes: </a:t>
            </a:r>
          </a:p>
          <a:p>
            <a:pPr algn="ctr"/>
            <a:r>
              <a:rPr lang="en-US" sz="1400" b="1" dirty="0" err="1" smtClean="0"/>
              <a:t>lncHUB</a:t>
            </a:r>
            <a:r>
              <a:rPr lang="en-US" sz="1400" b="1" dirty="0" smtClean="0"/>
              <a:t> lncRNA co-expression database; </a:t>
            </a:r>
          </a:p>
          <a:p>
            <a:pPr algn="ctr"/>
            <a:r>
              <a:rPr lang="en-US" sz="1400" b="1" dirty="0" smtClean="0"/>
              <a:t>top 30 significantly enriched records</a:t>
            </a:r>
            <a:endParaRPr lang="en-US" sz="1400" b="1" dirty="0"/>
          </a:p>
        </p:txBody>
      </p:sp>
      <p:sp>
        <p:nvSpPr>
          <p:cNvPr id="4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2550354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5227" y="765415"/>
            <a:ext cx="4981575" cy="5810250"/>
          </a:xfrm>
          <a:prstGeom prst="rect">
            <a:avLst/>
          </a:prstGeom>
        </p:spPr>
      </p:pic>
      <p:pic>
        <p:nvPicPr>
          <p:cNvPr id="3" name="Picture 2" descr="https://appyters.maayanlab.cloud/Enrichment_Analysis_Visualizer/07eaa3afd4eb745a668d45a726445b695bd6182b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936" y="1213160"/>
            <a:ext cx="6374291" cy="3839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47 genes</a:t>
            </a:r>
            <a:endParaRPr lang="en-US" b="1" dirty="0"/>
          </a:p>
        </p:txBody>
      </p:sp>
      <p:sp>
        <p:nvSpPr>
          <p:cNvPr id="5" name="5-Point Star 4"/>
          <p:cNvSpPr/>
          <p:nvPr/>
        </p:nvSpPr>
        <p:spPr>
          <a:xfrm>
            <a:off x="794988" y="6054331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6" name="TextBox 5"/>
          <p:cNvSpPr txBox="1"/>
          <p:nvPr/>
        </p:nvSpPr>
        <p:spPr>
          <a:xfrm>
            <a:off x="1353399" y="5989526"/>
            <a:ext cx="2731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etal Gonad Marker Genes</a:t>
            </a:r>
            <a:endParaRPr lang="en-US" b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719068" y="6528123"/>
            <a:ext cx="455943" cy="1466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353399" y="6348341"/>
            <a:ext cx="3886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ïve Primed Pluripotent States Genes</a:t>
            </a:r>
            <a:endParaRPr lang="en-US" b="1" dirty="0"/>
          </a:p>
        </p:txBody>
      </p:sp>
      <p:cxnSp>
        <p:nvCxnSpPr>
          <p:cNvPr id="9" name="Straight Connector 8"/>
          <p:cNvCxnSpPr/>
          <p:nvPr/>
        </p:nvCxnSpPr>
        <p:spPr>
          <a:xfrm flipV="1">
            <a:off x="8017549" y="3220481"/>
            <a:ext cx="0" cy="1049594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 flipV="1">
            <a:off x="8017549" y="2107673"/>
            <a:ext cx="5017" cy="851187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5-Point Star 13"/>
          <p:cNvSpPr/>
          <p:nvPr/>
        </p:nvSpPr>
        <p:spPr>
          <a:xfrm>
            <a:off x="6893755" y="2751819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5-Point Star 14"/>
          <p:cNvSpPr/>
          <p:nvPr/>
        </p:nvSpPr>
        <p:spPr>
          <a:xfrm>
            <a:off x="6906696" y="3391586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5-Point Star 15"/>
          <p:cNvSpPr/>
          <p:nvPr/>
        </p:nvSpPr>
        <p:spPr>
          <a:xfrm>
            <a:off x="6911086" y="3840158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5-Point Star 16"/>
          <p:cNvSpPr/>
          <p:nvPr/>
        </p:nvSpPr>
        <p:spPr>
          <a:xfrm>
            <a:off x="6893754" y="2510288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3587054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362313" y="1254125"/>
          <a:ext cx="11412744" cy="43486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86925"/>
                <a:gridCol w="815199"/>
                <a:gridCol w="951062"/>
                <a:gridCol w="951062"/>
                <a:gridCol w="951062"/>
                <a:gridCol w="951062"/>
                <a:gridCol w="1099866"/>
                <a:gridCol w="802257"/>
                <a:gridCol w="951063"/>
                <a:gridCol w="951062"/>
                <a:gridCol w="832448"/>
                <a:gridCol w="1069676"/>
              </a:tblGrid>
              <a:tr h="53154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onadal Mitotic Phase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Leydig</a:t>
                      </a:r>
                      <a:r>
                        <a:rPr lang="en-US" sz="1200" b="1" u="none" strike="noStrike" dirty="0">
                          <a:effectLst/>
                        </a:rPr>
                        <a:t> Precursor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onadal Endothelial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Sertoli</a:t>
                      </a:r>
                      <a:r>
                        <a:rPr lang="en-US" sz="1200" b="1" u="none" strike="noStrike" dirty="0">
                          <a:effectLst/>
                        </a:rPr>
                        <a:t>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itotic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Oogenesis Phase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igration Phase Fetal Germ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Endothelial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eiotic Prophase Fetal Germ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ranulosa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Leydig</a:t>
                      </a:r>
                      <a:r>
                        <a:rPr lang="en-US" sz="1200" b="1" u="none" strike="noStrike" dirty="0">
                          <a:effectLst/>
                        </a:rPr>
                        <a:t>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itotic Arrest Phase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B3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A5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A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ACD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AP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MT2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WDH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DHD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MT2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A5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GRMC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RPINE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FT1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STL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IM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XAD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NV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BFOX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ZNF7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HL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BTG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FR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L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ENM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OL22A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RPINE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D1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DH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MEM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KCNK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V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DH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ECA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STA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NAJB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LC25A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OLIM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DH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STA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F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OLIM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ZNF4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TD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PID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IM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4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EM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AB2I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IP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LC25A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MEM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BL1X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EFEM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DE5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LXN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RUNE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PN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DARB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F7I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FP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NMB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TM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IMELE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21ORF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4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VI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HK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CAF12L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B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DE4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OSBPL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EFEM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UFY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OX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OLIM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DUFA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3GAL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ZNF7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2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MEM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IRP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LXN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D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S6S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B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STL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OSBPL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O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RIG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VI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DUFA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BL1X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D9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OCS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F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O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HL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GRMC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H3GL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TM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ROD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SD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BO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ZNF4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O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O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TM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G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D9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OL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HX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FK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NTL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H3GL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HX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649351" y="388980"/>
            <a:ext cx="110956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Human-specific LTR7 and LTR5_Hs associated genes encoding markers of 12 distinct cell populations of fetal </a:t>
            </a:r>
            <a:r>
              <a:rPr lang="en-US" b="1" dirty="0"/>
              <a:t>g</a:t>
            </a:r>
            <a:r>
              <a:rPr lang="en-US" b="1" dirty="0" smtClean="0"/>
              <a:t>onads</a:t>
            </a:r>
            <a:endParaRPr lang="en-US" b="1" dirty="0"/>
          </a:p>
        </p:txBody>
      </p:sp>
      <p:sp>
        <p:nvSpPr>
          <p:cNvPr id="5" name="TextBox 3"/>
          <p:cNvSpPr txBox="1"/>
          <p:nvPr/>
        </p:nvSpPr>
        <p:spPr>
          <a:xfrm>
            <a:off x="0" y="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6189180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642412" y="961590"/>
            <a:ext cx="5109719" cy="5095840"/>
          </a:xfrm>
          <a:prstGeom prst="rect">
            <a:avLst/>
          </a:prstGeom>
        </p:spPr>
      </p:pic>
      <p:pic>
        <p:nvPicPr>
          <p:cNvPr id="3" name="Picture 2" descr="https://appyters.maayanlab.cloud/Enrichment_Analysis_Visualizer/475d65c5f4cf1fbecc41dfc5a220b19f21f85500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5192" y="2061713"/>
            <a:ext cx="5762446" cy="4270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698910" y="216453"/>
            <a:ext cx="10861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 smtClean="0"/>
              <a:t>Human-specific LTR7 and LTR5_Hs associated genes encoding markers of distinct cell populations of fetal gonads</a:t>
            </a:r>
          </a:p>
          <a:p>
            <a:pPr algn="ctr"/>
            <a:r>
              <a:rPr lang="en-US" b="1" dirty="0" smtClean="0"/>
              <a:t>Top 10 significantly enriched records</a:t>
            </a:r>
            <a:endParaRPr lang="en-US" b="1" dirty="0"/>
          </a:p>
        </p:txBody>
      </p:sp>
      <p:sp>
        <p:nvSpPr>
          <p:cNvPr id="5" name="TextBox 3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894715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342</Words>
  <Application>Microsoft Office PowerPoint</Application>
  <PresentationFormat>Widescreen</PresentationFormat>
  <Paragraphs>16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Supplementary Figure S2. GSEA of 247 genes linked by GREAT with 351 human-specific LTR7 and LTR5_Hs using the Enrichr bioinformatics platform (A – F). Related to Figure 5. Inference of putative phenotypic impacts of human-specific LTR7 &amp; LTR5_Hs loci based on GREAT algorithm-guided functional annotations of proximity placement-linked genes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lncHUB lncRNA co-expression</dc:title>
  <dc:creator>Guennadi Glinskii</dc:creator>
  <cp:lastModifiedBy>Guennadi Glinskii</cp:lastModifiedBy>
  <cp:revision>13</cp:revision>
  <dcterms:created xsi:type="dcterms:W3CDTF">2022-03-20T22:47:11Z</dcterms:created>
  <dcterms:modified xsi:type="dcterms:W3CDTF">2022-04-09T07:09:10Z</dcterms:modified>
</cp:coreProperties>
</file>